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1" r:id="rId2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41BE"/>
    <a:srgbClr val="DF6613"/>
    <a:srgbClr val="FF860D"/>
    <a:srgbClr val="E7E6E6"/>
    <a:srgbClr val="EB6E19"/>
    <a:srgbClr val="2DD19E"/>
    <a:srgbClr val="BA3906"/>
    <a:srgbClr val="D917D0"/>
    <a:srgbClr val="80319F"/>
    <a:srgbClr val="FF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63" autoAdjust="0"/>
    <p:restoredTop sz="72517" autoAdjust="0"/>
  </p:normalViewPr>
  <p:slideViewPr>
    <p:cSldViewPr snapToGrid="0">
      <p:cViewPr>
        <p:scale>
          <a:sx n="95" d="100"/>
          <a:sy n="95" d="100"/>
        </p:scale>
        <p:origin x="3056" y="-17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33FAEC-42DB-41A9-B7A4-541D6F542C7C}" type="datetimeFigureOut">
              <a:rPr lang="en-US" smtClean="0"/>
              <a:t>4/19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665D9B-96A9-4777-B24A-95D9A5FCF2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505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665D9B-96A9-4777-B24A-95D9A5FCF29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0162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328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699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309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80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929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731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065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452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938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889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9944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A3C7CA-CCB4-4716-8B65-F683F4292BE1}" type="datetimeFigureOut">
              <a:rPr lang="en-US" smtClean="0"/>
              <a:t>4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704F0-0109-409B-B900-45D289754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854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1.png"/><Relationship Id="rId5" Type="http://schemas.microsoft.com/office/2007/relationships/media" Target="../media/media3.mp4"/><Relationship Id="rId15" Type="http://schemas.openxmlformats.org/officeDocument/2006/relationships/hyperlink" Target="applewebdata://B28D231C-950E-4F15-946B-0AAD45E71F70/#_ENREF_40" TargetMode="External"/><Relationship Id="rId10" Type="http://schemas.openxmlformats.org/officeDocument/2006/relationships/notesSlide" Target="../notesSlides/notesSlide1.xml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2.xml"/><Relationship Id="rId1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mode1movie">
            <a:hlinkClick r:id="" action="ppaction://media"/>
            <a:extLst>
              <a:ext uri="{FF2B5EF4-FFF2-40B4-BE49-F238E27FC236}">
                <a16:creationId xmlns:a16="http://schemas.microsoft.com/office/drawing/2014/main" id="{93FBC4D0-4669-4A32-90F2-DDB82EFA7AB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11"/>
          <a:srcRect l="22573" r="29774"/>
          <a:stretch/>
        </p:blipFill>
        <p:spPr>
          <a:xfrm>
            <a:off x="232095" y="703842"/>
            <a:ext cx="3135946" cy="341376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93EFABA-6C0B-4FDC-A752-0A1781DE820C}"/>
              </a:ext>
            </a:extLst>
          </p:cNvPr>
          <p:cNvSpPr txBox="1"/>
          <p:nvPr/>
        </p:nvSpPr>
        <p:spPr>
          <a:xfrm>
            <a:off x="1706735" y="3709988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M mode 1</a:t>
            </a:r>
          </a:p>
        </p:txBody>
      </p:sp>
      <p:pic>
        <p:nvPicPr>
          <p:cNvPr id="10" name="mode2movie">
            <a:hlinkClick r:id="" action="ppaction://media"/>
            <a:extLst>
              <a:ext uri="{FF2B5EF4-FFF2-40B4-BE49-F238E27FC236}">
                <a16:creationId xmlns:a16="http://schemas.microsoft.com/office/drawing/2014/main" id="{292763C4-CE6C-47B1-82EE-3C18407F7962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12"/>
          <a:srcRect l="25778" r="23223" b="6798"/>
          <a:stretch/>
        </p:blipFill>
        <p:spPr>
          <a:xfrm>
            <a:off x="253217" y="4507072"/>
            <a:ext cx="2932657" cy="363870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9B3BD63-0A5F-449F-B7EE-59DF5FA0E70D}"/>
              </a:ext>
            </a:extLst>
          </p:cNvPr>
          <p:cNvSpPr txBox="1"/>
          <p:nvPr/>
        </p:nvSpPr>
        <p:spPr>
          <a:xfrm>
            <a:off x="1719545" y="7753588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M mode 2</a:t>
            </a:r>
          </a:p>
        </p:txBody>
      </p:sp>
      <p:pic>
        <p:nvPicPr>
          <p:cNvPr id="12" name="mode3movie">
            <a:hlinkClick r:id="" action="ppaction://media"/>
            <a:extLst>
              <a:ext uri="{FF2B5EF4-FFF2-40B4-BE49-F238E27FC236}">
                <a16:creationId xmlns:a16="http://schemas.microsoft.com/office/drawing/2014/main" id="{4F2C7192-3935-4DD2-A975-4D2E474C8313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 rotWithShape="1">
          <a:blip r:embed="rId13"/>
          <a:srcRect l="21333" r="21889" b="4849"/>
          <a:stretch/>
        </p:blipFill>
        <p:spPr>
          <a:xfrm>
            <a:off x="3489960" y="703842"/>
            <a:ext cx="3110659" cy="341376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3CE667F-B6A8-447C-BF91-A04C1AB10A79}"/>
              </a:ext>
            </a:extLst>
          </p:cNvPr>
          <p:cNvSpPr txBox="1"/>
          <p:nvPr/>
        </p:nvSpPr>
        <p:spPr>
          <a:xfrm>
            <a:off x="5151265" y="3626168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M mode 3</a:t>
            </a:r>
          </a:p>
        </p:txBody>
      </p:sp>
      <p:pic>
        <p:nvPicPr>
          <p:cNvPr id="15" name="mode4moview">
            <a:hlinkClick r:id="" action="ppaction://media"/>
            <a:extLst>
              <a:ext uri="{FF2B5EF4-FFF2-40B4-BE49-F238E27FC236}">
                <a16:creationId xmlns:a16="http://schemas.microsoft.com/office/drawing/2014/main" id="{544EE2BE-8756-4E3B-907F-9422595535B9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 rotWithShape="1">
          <a:blip r:embed="rId14"/>
          <a:srcRect l="27000" r="28555"/>
          <a:stretch/>
        </p:blipFill>
        <p:spPr>
          <a:xfrm>
            <a:off x="3489960" y="4507072"/>
            <a:ext cx="3110658" cy="363072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E16BC12-95CC-40B1-8881-F13428FCE1C4}"/>
              </a:ext>
            </a:extLst>
          </p:cNvPr>
          <p:cNvSpPr txBox="1"/>
          <p:nvPr/>
        </p:nvSpPr>
        <p:spPr>
          <a:xfrm>
            <a:off x="5150744" y="7737396"/>
            <a:ext cx="14269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M mode 4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8FDC47C-3602-3365-4187-94821E9451E5}"/>
              </a:ext>
            </a:extLst>
          </p:cNvPr>
          <p:cNvSpPr/>
          <p:nvPr/>
        </p:nvSpPr>
        <p:spPr>
          <a:xfrm>
            <a:off x="0" y="8527263"/>
            <a:ext cx="696221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CC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vie S1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imations of the slowest four ANM modes (ANM1-ANM4) accessible to </a:t>
            </a:r>
            <a:r>
              <a:rPr lang="en-US" dirty="0">
                <a:latin typeface="Symbol" pitchFamily="2" charset="2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AR. The movies were generated using the 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ynOmics</a:t>
            </a:r>
            <a:r>
              <a:rPr lang="en-US" i="1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15" tooltip="Li, 2017 #642"/>
              </a:rPr>
              <a:t>4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erver.  ANM2 and ANM1 correlate with the PC1 and PC3 obtained from ensemble analysis of structures resolved for Class A GPCR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64859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74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874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1874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1874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9" repeatCount="indefinite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25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31" repeatCount="indefinite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32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3" fill="hold">
                      <p:stCondLst>
                        <p:cond delay="0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6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 vol="80000">
                <p:cTn id="37" repeatCount="indefinite" fill="hold" display="0">
                  <p:stCondLst>
                    <p:cond delay="indefinite"/>
                  </p:stCondLst>
                </p:cTn>
                <p:tgtEl>
                  <p:spTgt spid="15"/>
                </p:tgtEl>
              </p:cMediaNode>
            </p:video>
            <p:seq concurrent="1" nextAc="seek">
              <p:cTn id="38" restart="whenNotActive" fill="hold" evtFilter="cancelBubble" nodeType="interactiveSeq">
                <p:stCondLst>
                  <p:cond evt="onClick" delay="0">
                    <p:tgtEl>
                      <p:spTgt spid="1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9" fill="hold">
                      <p:stCondLst>
                        <p:cond delay="0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2" dur="1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78</TotalTime>
  <Words>60</Words>
  <Application>Microsoft Macintosh PowerPoint</Application>
  <PresentationFormat>A4 Paper (210x297 mm)</PresentationFormat>
  <Paragraphs>6</Paragraphs>
  <Slides>1</Slides>
  <Notes>1</Notes>
  <HiddenSlides>0</HiddenSlides>
  <MMClips>4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gert, Bentley Morse</dc:creator>
  <cp:lastModifiedBy>Doruker, Pemra</cp:lastModifiedBy>
  <cp:revision>156</cp:revision>
  <cp:lastPrinted>2021-12-01T01:23:17Z</cp:lastPrinted>
  <dcterms:created xsi:type="dcterms:W3CDTF">2021-09-16T19:10:32Z</dcterms:created>
  <dcterms:modified xsi:type="dcterms:W3CDTF">2022-04-19T15:41:03Z</dcterms:modified>
</cp:coreProperties>
</file>